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305" r:id="rId2"/>
    <p:sldId id="272" r:id="rId3"/>
    <p:sldId id="258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32" userDrawn="1">
          <p15:clr>
            <a:srgbClr val="A4A3A4"/>
          </p15:clr>
        </p15:guide>
        <p15:guide id="2" pos="33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5017"/>
    <p:restoredTop sz="91918" autoAdjust="0"/>
  </p:normalViewPr>
  <p:slideViewPr>
    <p:cSldViewPr>
      <p:cViewPr varScale="1">
        <p:scale>
          <a:sx n="104" d="100"/>
          <a:sy n="104" d="100"/>
        </p:scale>
        <p:origin x="1422" y="96"/>
      </p:cViewPr>
      <p:guideLst>
        <p:guide orient="horz" pos="1632"/>
        <p:guide pos="33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Webb, Tonya" userId="3bf9fd45-fe99-4886-b978-9357ee7638b4" providerId="ADAL" clId="{F4BC2AB1-CA1E-6046-B8DA-ED5B39EF9F1C}"/>
    <pc:docChg chg="modSld">
      <pc:chgData name="Webb, Tonya" userId="3bf9fd45-fe99-4886-b978-9357ee7638b4" providerId="ADAL" clId="{F4BC2AB1-CA1E-6046-B8DA-ED5B39EF9F1C}" dt="2024-11-16T05:01:17.067" v="3" actId="20577"/>
      <pc:docMkLst>
        <pc:docMk/>
      </pc:docMkLst>
      <pc:sldChg chg="modSp mod">
        <pc:chgData name="Webb, Tonya" userId="3bf9fd45-fe99-4886-b978-9357ee7638b4" providerId="ADAL" clId="{F4BC2AB1-CA1E-6046-B8DA-ED5B39EF9F1C}" dt="2024-11-16T05:01:17.067" v="3" actId="20577"/>
        <pc:sldMkLst>
          <pc:docMk/>
          <pc:sldMk cId="3688406272" sldId="305"/>
        </pc:sldMkLst>
        <pc:spChg chg="mod">
          <ac:chgData name="Webb, Tonya" userId="3bf9fd45-fe99-4886-b978-9357ee7638b4" providerId="ADAL" clId="{F4BC2AB1-CA1E-6046-B8DA-ED5B39EF9F1C}" dt="2024-11-16T05:01:17.067" v="3" actId="20577"/>
          <ac:spMkLst>
            <pc:docMk/>
            <pc:sldMk cId="3688406272" sldId="305"/>
            <ac:spMk id="2" creationId="{00000000-0000-0000-0000-000000000000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8BF17B6-F84F-4D00-AD86-86D0FD955D2B}" type="datetimeFigureOut">
              <a:rPr lang="en-US" smtClean="0"/>
              <a:pPr/>
              <a:t>11/16/2024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F53CEB3-8A7E-4B2C-A981-9067CC15525D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917760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baseline="0" dirty="0"/>
              <a:t>h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F53CEB3-8A7E-4B2C-A981-9067CC15525D}" type="slidenum">
              <a:rPr lang="en-US" smtClean="0"/>
              <a:pPr/>
              <a:t>3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9107747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335B20-66B3-4426-9CC4-BE92CBE2766D}" type="datetimeFigureOut">
              <a:rPr lang="en-US" smtClean="0"/>
              <a:pPr/>
              <a:t>11/16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A3B3B3-B01E-49DA-AE47-74A985E2BDFC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705447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335B20-66B3-4426-9CC4-BE92CBE2766D}" type="datetimeFigureOut">
              <a:rPr lang="en-US" smtClean="0"/>
              <a:pPr/>
              <a:t>11/16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A3B3B3-B01E-49DA-AE47-74A985E2BDFC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251730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335B20-66B3-4426-9CC4-BE92CBE2766D}" type="datetimeFigureOut">
              <a:rPr lang="en-US" smtClean="0"/>
              <a:pPr/>
              <a:t>11/16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A3B3B3-B01E-49DA-AE47-74A985E2BDFC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298184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335B20-66B3-4426-9CC4-BE92CBE2766D}" type="datetimeFigureOut">
              <a:rPr lang="en-US" smtClean="0"/>
              <a:pPr/>
              <a:t>11/16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A3B3B3-B01E-49DA-AE47-74A985E2BDFC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835866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335B20-66B3-4426-9CC4-BE92CBE2766D}" type="datetimeFigureOut">
              <a:rPr lang="en-US" smtClean="0"/>
              <a:pPr/>
              <a:t>11/16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A3B3B3-B01E-49DA-AE47-74A985E2BDFC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975526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335B20-66B3-4426-9CC4-BE92CBE2766D}" type="datetimeFigureOut">
              <a:rPr lang="en-US" smtClean="0"/>
              <a:pPr/>
              <a:t>11/16/20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A3B3B3-B01E-49DA-AE47-74A985E2BDFC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47043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335B20-66B3-4426-9CC4-BE92CBE2766D}" type="datetimeFigureOut">
              <a:rPr lang="en-US" smtClean="0"/>
              <a:pPr/>
              <a:t>11/16/2024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A3B3B3-B01E-49DA-AE47-74A985E2BDFC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951796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335B20-66B3-4426-9CC4-BE92CBE2766D}" type="datetimeFigureOut">
              <a:rPr lang="en-US" smtClean="0"/>
              <a:pPr/>
              <a:t>11/16/2024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A3B3B3-B01E-49DA-AE47-74A985E2BDFC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00935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335B20-66B3-4426-9CC4-BE92CBE2766D}" type="datetimeFigureOut">
              <a:rPr lang="en-US" smtClean="0"/>
              <a:pPr/>
              <a:t>11/16/2024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A3B3B3-B01E-49DA-AE47-74A985E2BDFC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641758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335B20-66B3-4426-9CC4-BE92CBE2766D}" type="datetimeFigureOut">
              <a:rPr lang="en-US" smtClean="0"/>
              <a:pPr/>
              <a:t>11/16/20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A3B3B3-B01E-49DA-AE47-74A985E2BDFC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795436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3335B20-66B3-4426-9CC4-BE92CBE2766D}" type="datetimeFigureOut">
              <a:rPr lang="en-US" smtClean="0"/>
              <a:pPr/>
              <a:t>11/16/2024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A3B3B3-B01E-49DA-AE47-74A985E2BDFC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142319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335B20-66B3-4426-9CC4-BE92CBE2766D}" type="datetimeFigureOut">
              <a:rPr lang="en-US" smtClean="0"/>
              <a:pPr/>
              <a:t>11/16/2024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A3B3B3-B01E-49DA-AE47-74A985E2BDFC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766529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/>
        </p:nvGraphicFramePr>
        <p:xfrm>
          <a:off x="838201" y="762000"/>
          <a:ext cx="7543797" cy="5253256"/>
        </p:xfrm>
        <a:graphic>
          <a:graphicData uri="http://schemas.openxmlformats.org/drawingml/2006/table">
            <a:tbl>
              <a:tblPr/>
              <a:tblGrid>
                <a:gridCol w="85603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85603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03178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03178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945203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856034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856034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856034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856034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856034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</a:tblGrid>
              <a:tr h="22492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2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High NKT responder</a:t>
                      </a:r>
                    </a:p>
                  </a:txBody>
                  <a:tcPr marL="5955" marR="5955" marT="59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5955" marR="5955" marT="59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5955" marR="5955" marT="59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5955" marR="5955" marT="595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algn="l" rtl="0" fontAlgn="ctr"/>
                      <a:r>
                        <a:rPr lang="en-US" sz="72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                                                     Peritumoral involvement %</a:t>
                      </a:r>
                    </a:p>
                  </a:txBody>
                  <a:tcPr marL="5955" marR="5955" marT="59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endParaRPr lang="en-US" sz="72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14008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ID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Diagnosis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ER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R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Her2Neu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Grade 1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rade 2 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rade 3 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Intratumoral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93526"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</a:t>
                      </a:r>
                    </a:p>
                  </a:txBody>
                  <a:tcPr marL="5955" marR="5955" marT="59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nvasive Ductal Carcinoma</a:t>
                      </a:r>
                    </a:p>
                  </a:txBody>
                  <a:tcPr marL="5955" marR="5955" marT="59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</a:t>
                      </a:r>
                    </a:p>
                  </a:txBody>
                  <a:tcPr marL="5955" marR="5955" marT="59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</a:t>
                      </a:r>
                    </a:p>
                  </a:txBody>
                  <a:tcPr marL="5955" marR="5955" marT="59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5955" marR="5955" marT="59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D3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5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rade 1 in 40% of tumor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1400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D4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5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0% of T cells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1400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D8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5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0% of T cells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93526"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</a:t>
                      </a:r>
                    </a:p>
                  </a:txBody>
                  <a:tcPr marL="5955" marR="5955" marT="59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nvasive Ductal Carcinoma</a:t>
                      </a:r>
                    </a:p>
                  </a:txBody>
                  <a:tcPr marL="5955" marR="5955" marT="59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</a:t>
                      </a:r>
                    </a:p>
                  </a:txBody>
                  <a:tcPr marL="5955" marR="5955" marT="59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5955" marR="5955" marT="59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5955" marR="5955" marT="59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D3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5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rade 1 in 30% of tumor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1400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D4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5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% of T cells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1400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D8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0% of T cells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21196"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3</a:t>
                      </a:r>
                    </a:p>
                  </a:txBody>
                  <a:tcPr marL="5955" marR="5955" marT="59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nvasive Ductal Carcinoma</a:t>
                      </a:r>
                    </a:p>
                  </a:txBody>
                  <a:tcPr marL="5955" marR="5955" marT="59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</a:t>
                      </a:r>
                    </a:p>
                  </a:txBody>
                  <a:tcPr marL="5955" marR="5955" marT="59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</a:t>
                      </a:r>
                    </a:p>
                  </a:txBody>
                  <a:tcPr marL="5955" marR="5955" marT="59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5955" marR="5955" marT="59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D3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imited tissue remaining 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1360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D4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1360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D8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13601"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8</a:t>
                      </a:r>
                    </a:p>
                  </a:txBody>
                  <a:tcPr marL="5955" marR="5955" marT="59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nvasive Ductal Carcinoma</a:t>
                      </a:r>
                    </a:p>
                  </a:txBody>
                  <a:tcPr marL="5955" marR="5955" marT="59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5955" marR="5955" marT="59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5955" marR="5955" marT="59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5955" marR="5955" marT="59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D3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rade 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1360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D4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1360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D8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93526"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7</a:t>
                      </a:r>
                    </a:p>
                  </a:txBody>
                  <a:tcPr marL="5955" marR="5955" marT="59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nvasive Ductal Carcinoma</a:t>
                      </a:r>
                    </a:p>
                  </a:txBody>
                  <a:tcPr marL="5955" marR="5955" marT="59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</a:t>
                      </a:r>
                    </a:p>
                  </a:txBody>
                  <a:tcPr marL="5955" marR="5955" marT="59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</a:t>
                      </a:r>
                    </a:p>
                  </a:txBody>
                  <a:tcPr marL="5955" marR="5955" marT="59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orderline 2+</a:t>
                      </a:r>
                    </a:p>
                  </a:txBody>
                  <a:tcPr marL="5955" marR="5955" marT="59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D3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rade 1 in 30% of tumor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1400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D4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% of T cells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1400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D8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0% of T cells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13601">
                <a:tc>
                  <a:txBody>
                    <a:bodyPr/>
                    <a:lstStyle/>
                    <a:p>
                      <a:pPr algn="l" fontAlgn="b"/>
                      <a:endParaRPr lang="en-US" sz="72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55" marR="5955" marT="595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2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55" marR="5955" marT="595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2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55" marR="5955" marT="595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2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55" marR="5955" marT="595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2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55" marR="5955" marT="595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2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55" marR="5955" marT="595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2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55" marR="5955" marT="595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2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55" marR="5955" marT="595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2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55" marR="5955" marT="595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72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55" marR="5955" marT="595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22492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72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Low NKT responder</a:t>
                      </a:r>
                    </a:p>
                  </a:txBody>
                  <a:tcPr marL="5955" marR="5955" marT="59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l" fontAlgn="ctr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5955" marR="5955" marT="59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5955" marR="5955" marT="59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5955" marR="5955" marT="595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rtl="0" fontAlgn="ctr"/>
                      <a:r>
                        <a:rPr lang="en-US" sz="72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     Peritumoral involvement %</a:t>
                      </a:r>
                    </a:p>
                  </a:txBody>
                  <a:tcPr marL="5955" marR="5955" marT="59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5955" marR="5955" marT="5955" marB="0" anchor="b">
                    <a:lnL w="635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14008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ID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Diagnosis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ER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PR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Her2Neu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 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rade 1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rade 2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Grade 3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/>
                        </a:rPr>
                        <a:t>Intratumoral 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193526"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</a:t>
                      </a:r>
                    </a:p>
                  </a:txBody>
                  <a:tcPr marL="5955" marR="5955" marT="59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nvasive Colloid (Mucinous)</a:t>
                      </a:r>
                    </a:p>
                  </a:txBody>
                  <a:tcPr marL="5955" marR="5955" marT="59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</a:t>
                      </a:r>
                    </a:p>
                  </a:txBody>
                  <a:tcPr marL="5955" marR="5955" marT="59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</a:t>
                      </a:r>
                    </a:p>
                  </a:txBody>
                  <a:tcPr marL="5955" marR="5955" marT="59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5955" marR="5955" marT="59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D3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rade 1 in 10% of tumor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11400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D4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% of T cells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11400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D8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0% of T cells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193526"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</a:t>
                      </a:r>
                    </a:p>
                  </a:txBody>
                  <a:tcPr marL="5955" marR="5955" marT="59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nvasive Ductal Carcinoma</a:t>
                      </a:r>
                    </a:p>
                  </a:txBody>
                  <a:tcPr marL="5955" marR="5955" marT="59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</a:t>
                      </a:r>
                    </a:p>
                  </a:txBody>
                  <a:tcPr marL="5955" marR="5955" marT="59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</a:t>
                      </a:r>
                    </a:p>
                  </a:txBody>
                  <a:tcPr marL="5955" marR="5955" marT="59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5955" marR="5955" marT="59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D3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rade 1 in 5% of tumor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11400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D4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0% of T cells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11400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D8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0% of T cells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193526"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9</a:t>
                      </a:r>
                    </a:p>
                  </a:txBody>
                  <a:tcPr marL="5955" marR="5955" marT="59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nvasive Ductal Carcinoma</a:t>
                      </a:r>
                    </a:p>
                  </a:txBody>
                  <a:tcPr marL="5955" marR="5955" marT="59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</a:t>
                      </a:r>
                    </a:p>
                  </a:txBody>
                  <a:tcPr marL="5955" marR="5955" marT="59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</a:t>
                      </a:r>
                    </a:p>
                  </a:txBody>
                  <a:tcPr marL="5955" marR="5955" marT="59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5955" marR="5955" marT="59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D3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5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rade 2 in 40% of tumor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11400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D4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5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0% of T cells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11400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D8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0% of T cells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  <a:tr h="193526"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0</a:t>
                      </a:r>
                    </a:p>
                  </a:txBody>
                  <a:tcPr marL="5955" marR="5955" marT="59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nvasive Ductal Carcinoma</a:t>
                      </a:r>
                    </a:p>
                  </a:txBody>
                  <a:tcPr marL="5955" marR="5955" marT="59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</a:t>
                      </a:r>
                    </a:p>
                  </a:txBody>
                  <a:tcPr marL="5955" marR="5955" marT="59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</a:t>
                      </a:r>
                    </a:p>
                  </a:txBody>
                  <a:tcPr marL="5955" marR="5955" marT="59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-</a:t>
                      </a:r>
                    </a:p>
                  </a:txBody>
                  <a:tcPr marL="5955" marR="5955" marT="59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D3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rade 2 in 20% of tumor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9"/>
                  </a:ext>
                </a:extLst>
              </a:tr>
              <a:tr h="11400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D4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0% of T cells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0"/>
                  </a:ext>
                </a:extLst>
              </a:tr>
              <a:tr h="11400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D8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0% of T cells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1"/>
                  </a:ext>
                </a:extLst>
              </a:tr>
              <a:tr h="193526"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3</a:t>
                      </a:r>
                    </a:p>
                  </a:txBody>
                  <a:tcPr marL="5955" marR="5955" marT="59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nvasive Ductal Carcinoma</a:t>
                      </a:r>
                    </a:p>
                  </a:txBody>
                  <a:tcPr marL="5955" marR="5955" marT="59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</a:t>
                      </a:r>
                    </a:p>
                  </a:txBody>
                  <a:tcPr marL="5955" marR="5955" marT="59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</a:t>
                      </a:r>
                    </a:p>
                  </a:txBody>
                  <a:tcPr marL="5955" marR="5955" marT="59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rtl="0" fontAlgn="ctr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+</a:t>
                      </a:r>
                    </a:p>
                  </a:txBody>
                  <a:tcPr marL="5955" marR="5955" marT="5955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D3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rade 1 in 30% of tumor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2"/>
                  </a:ext>
                </a:extLst>
              </a:tr>
              <a:tr h="11400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D4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2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% of T cells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3"/>
                  </a:ext>
                </a:extLst>
              </a:tr>
              <a:tr h="11400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D8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0% of T cells</a:t>
                      </a:r>
                    </a:p>
                  </a:txBody>
                  <a:tcPr marL="5955" marR="5955" marT="595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4"/>
                  </a:ext>
                </a:extLst>
              </a:tr>
            </a:tbl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1295400" y="420839"/>
            <a:ext cx="640080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/>
              <a:t>Supplemental Table </a:t>
            </a:r>
            <a:r>
              <a:rPr lang="en-US" altLang="zh-CN" sz="1000" b="1" dirty="0"/>
              <a:t>S</a:t>
            </a:r>
            <a:r>
              <a:rPr lang="en-US" sz="1000" b="1" dirty="0"/>
              <a:t>1. CD3, CD4, CD8, and PD-L1 expression in high responders compared to low responders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762000" y="6019800"/>
            <a:ext cx="78486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Intratumoral lymphocytes :Grade 0, Grade 1: 1-10 lymphocytes per HPF, Grade 2: 10-20 lymphocytes per HPF, Grade 3: &gt;20 lymphocytes per HPF; Peritumoral lymphocytes : Grade 0, Grade 1: no distinct clusters but scattered lymphocytes, Grade 2: small clusters, Grade 3: large clusters </a:t>
            </a:r>
          </a:p>
        </p:txBody>
      </p:sp>
    </p:spTree>
    <p:extLst>
      <p:ext uri="{BB962C8B-B14F-4D97-AF65-F5344CB8AC3E}">
        <p14:creationId xmlns:p14="http://schemas.microsoft.com/office/powerpoint/2010/main" val="36884062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B4D92B66-E4B9-347C-F589-7DCFEC97ACD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32000" y="2247900"/>
            <a:ext cx="5080000" cy="23622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B7CCDC50-AEDF-C5B5-0E34-7A61F986FFF4}"/>
              </a:ext>
            </a:extLst>
          </p:cNvPr>
          <p:cNvSpPr txBox="1"/>
          <p:nvPr/>
        </p:nvSpPr>
        <p:spPr>
          <a:xfrm>
            <a:off x="1333500" y="4724400"/>
            <a:ext cx="6477000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457200" marR="0" indent="0" algn="just">
              <a:spcBef>
                <a:spcPts val="600"/>
              </a:spcBef>
              <a:spcAft>
                <a:spcPts val="0"/>
              </a:spcAft>
            </a:pPr>
            <a:r>
              <a:rPr lang="en-US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l Figure S1</a:t>
            </a:r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Validation of the immune gene signatures. Differential expression of TNF-a, LAG3, and LIGHT were confirmed using specimens from the entire breast cancer patient cohort.   Patients with functional NKT cells (high responders) also had high induction of TNF-a, LAG-3 and LIGHT, compared to those without functional NKT cells (low responders).</a:t>
            </a:r>
          </a:p>
        </p:txBody>
      </p:sp>
    </p:spTree>
    <p:extLst>
      <p:ext uri="{BB962C8B-B14F-4D97-AF65-F5344CB8AC3E}">
        <p14:creationId xmlns:p14="http://schemas.microsoft.com/office/powerpoint/2010/main" val="86234996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Grp="1"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038600" y="685800"/>
            <a:ext cx="2830154" cy="182107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7" name="Picture 6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066800" y="685800"/>
            <a:ext cx="2812841" cy="190871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8" name="TextBox 7"/>
          <p:cNvSpPr txBox="1"/>
          <p:nvPr/>
        </p:nvSpPr>
        <p:spPr>
          <a:xfrm>
            <a:off x="1066800" y="609600"/>
            <a:ext cx="36567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A.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4217416" y="3022092"/>
            <a:ext cx="36452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D.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C387E30B-E5D3-5F3B-EDA8-44E17447DEE4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51644"/>
          <a:stretch/>
        </p:blipFill>
        <p:spPr>
          <a:xfrm>
            <a:off x="3733800" y="2824738"/>
            <a:ext cx="3695700" cy="224155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5D85AC0F-3B74-0686-5886-A4AB1B0AB8B4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b="51644"/>
          <a:stretch/>
        </p:blipFill>
        <p:spPr>
          <a:xfrm>
            <a:off x="511194" y="2895600"/>
            <a:ext cx="3695700" cy="224155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B7108130-C397-D2D6-382D-BB374AB1B20D}"/>
              </a:ext>
            </a:extLst>
          </p:cNvPr>
          <p:cNvSpPr txBox="1"/>
          <p:nvPr/>
        </p:nvSpPr>
        <p:spPr>
          <a:xfrm>
            <a:off x="244494" y="5066288"/>
            <a:ext cx="7924799" cy="146193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457200" algn="just">
              <a:spcBef>
                <a:spcPts val="600"/>
              </a:spcBef>
            </a:pPr>
            <a:r>
              <a:rPr lang="en-US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upplemental Figure S2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. Human and Mouse Breast Cancer Cell Lines express Ganglioside GD3. (A) MCF-7 and (B) 410.4 cells were stained for GD3 and analyzed by flow cytometry.  (C) DN32.D3 NKT cell hybridomas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were pretreated 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4 hours with the indicated concentrations of GD3, then stimulated using L-CD1d cells. 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(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)LCD1d cells were treated with conditioned media from MCF7 cells in the presence or absence of 10</a:t>
            </a:r>
            <a:r>
              <a:rPr lang="en-US" sz="1200" dirty="0">
                <a:effectLst/>
                <a:latin typeface="Symbol" pitchFamily="2" charset="2"/>
                <a:ea typeface="Times New Roman" panose="02020603050405020304" pitchFamily="18" charset="0"/>
                <a:cs typeface="Arial" panose="020B0604020202020204" pitchFamily="34" charset="0"/>
              </a:rPr>
              <a:t>m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g/ml GD3 mAb (clone R24) for 4 h, then washed extensively and cocultured with a panel of NKT cell hybridomas. IL-2 production was measured as an indication of NKT cell activation. </a:t>
            </a:r>
          </a:p>
          <a:p>
            <a:pPr marL="457200" algn="just">
              <a:spcBef>
                <a:spcPts val="600"/>
              </a:spcBef>
            </a:pPr>
            <a:endParaRPr lang="en-US" sz="12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FBF4919-029A-CF3F-A5D1-993AB0323FD7}"/>
              </a:ext>
            </a:extLst>
          </p:cNvPr>
          <p:cNvSpPr txBox="1"/>
          <p:nvPr/>
        </p:nvSpPr>
        <p:spPr>
          <a:xfrm>
            <a:off x="1066800" y="3022092"/>
            <a:ext cx="8294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C.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B9FCA81C-EF9C-169C-3621-2C631B37CC34}"/>
              </a:ext>
            </a:extLst>
          </p:cNvPr>
          <p:cNvSpPr txBox="1"/>
          <p:nvPr/>
        </p:nvSpPr>
        <p:spPr>
          <a:xfrm>
            <a:off x="4217416" y="609600"/>
            <a:ext cx="35458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B.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8618</TotalTime>
  <Words>657</Words>
  <Application>Microsoft Office PowerPoint</Application>
  <PresentationFormat>On-screen Show (4:3)</PresentationFormat>
  <Paragraphs>242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Symbol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, Junxin</dc:creator>
  <cp:lastModifiedBy>MDPI</cp:lastModifiedBy>
  <cp:revision>36</cp:revision>
  <dcterms:created xsi:type="dcterms:W3CDTF">2013-06-27T19:58:10Z</dcterms:created>
  <dcterms:modified xsi:type="dcterms:W3CDTF">2024-11-16T07:44:31Z</dcterms:modified>
</cp:coreProperties>
</file>